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39868475" cy="2240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056" userDrawn="1">
          <p15:clr>
            <a:srgbClr val="A4A3A4"/>
          </p15:clr>
        </p15:guide>
        <p15:guide id="2" pos="125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E6963"/>
    <a:srgbClr val="EF6E64"/>
    <a:srgbClr val="74948F"/>
    <a:srgbClr val="575757"/>
    <a:srgbClr val="989F9E"/>
    <a:srgbClr val="6A7472"/>
    <a:srgbClr val="734A53"/>
    <a:srgbClr val="39161F"/>
    <a:srgbClr val="501C29"/>
    <a:srgbClr val="E6F4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26" d="100"/>
          <a:sy n="26" d="100"/>
        </p:scale>
        <p:origin x="105" y="270"/>
      </p:cViewPr>
      <p:guideLst>
        <p:guide orient="horz" pos="7056"/>
        <p:guide pos="125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na\Box%20Sync\MCR%20Year\Research\Caroline\COVID%20IMPACT%20QUAL\Copy%20of%20summary%20sta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na\Box%20Sync\MCR%20Year\Research\Caroline\COVID%20IMPACT%20QUAL\Copy%20of%20summary%20sta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ana\Box%20Sync\MCR%20Year\Research\Caroline\COVID%20IMPACT%20QUAL\Copy%20of%20summary%20sta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800" b="1" baseline="0" dirty="0">
                <a:solidFill>
                  <a:schemeClr val="bg1"/>
                </a:solidFill>
              </a:rPr>
              <a:t>Cell phone status</a:t>
            </a:r>
          </a:p>
        </c:rich>
      </c:tx>
      <c:layout>
        <c:manualLayout>
          <c:xMode val="edge"/>
          <c:yMode val="edge"/>
          <c:x val="0.33407071630122659"/>
          <c:y val="2.06676573609441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3834988884379252"/>
          <c:y val="0.17511976262021756"/>
          <c:w val="0.63898019298705055"/>
          <c:h val="0.5957936807482177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EF6E64"/>
            </a:solidFill>
            <a:ln>
              <a:solidFill>
                <a:srgbClr val="EF6E64"/>
              </a:solidFill>
            </a:ln>
            <a:effectLst/>
          </c:spPr>
          <c:invertIfNegative val="0"/>
          <c:cat>
            <c:strRef>
              <c:f>Sheet1!$L$75:$L$76</c:f>
              <c:strCache>
                <c:ptCount val="2"/>
                <c:pt idx="0">
                  <c:v>Cell Phone</c:v>
                </c:pt>
                <c:pt idx="1">
                  <c:v>No Phone</c:v>
                </c:pt>
              </c:strCache>
            </c:strRef>
          </c:cat>
          <c:val>
            <c:numRef>
              <c:f>Sheet1!$M$75:$M$76</c:f>
              <c:numCache>
                <c:formatCode>General</c:formatCode>
                <c:ptCount val="2"/>
                <c:pt idx="0">
                  <c:v>14</c:v>
                </c:pt>
                <c:pt idx="1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34-4EB4-A941-A71DACA6B5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214687"/>
        <c:axId val="159298671"/>
      </c:barChart>
      <c:catAx>
        <c:axId val="1121468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2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298671"/>
        <c:crosses val="autoZero"/>
        <c:auto val="1"/>
        <c:lblAlgn val="ctr"/>
        <c:lblOffset val="100"/>
        <c:noMultiLvlLbl val="0"/>
      </c:catAx>
      <c:valAx>
        <c:axId val="159298671"/>
        <c:scaling>
          <c:orientation val="minMax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baseline="0" dirty="0">
                    <a:solidFill>
                      <a:schemeClr val="bg1"/>
                    </a:solidFill>
                  </a:rPr>
                  <a:t>Participants (n=27)</a:t>
                </a:r>
              </a:p>
            </c:rich>
          </c:tx>
          <c:layout>
            <c:manualLayout>
              <c:xMode val="edge"/>
              <c:yMode val="edge"/>
              <c:x val="0.33548859705927236"/>
              <c:y val="0.901951043346649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2146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bg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800" b="1" baseline="0" dirty="0">
                <a:solidFill>
                  <a:schemeClr val="bg1"/>
                </a:solidFill>
              </a:rPr>
              <a:t>Housing status</a:t>
            </a:r>
          </a:p>
        </c:rich>
      </c:tx>
      <c:layout>
        <c:manualLayout>
          <c:xMode val="edge"/>
          <c:yMode val="edge"/>
          <c:x val="0.33484263933031283"/>
          <c:y val="1.652062964845964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AE6963"/>
            </a:solidFill>
            <a:ln>
              <a:solidFill>
                <a:srgbClr val="AE6963"/>
              </a:solidFill>
            </a:ln>
            <a:effectLst/>
          </c:spPr>
          <c:invertIfNegative val="0"/>
          <c:cat>
            <c:strRef>
              <c:f>Sheet1!$L$81:$P$81</c:f>
              <c:strCache>
                <c:ptCount val="5"/>
                <c:pt idx="0">
                  <c:v>Housed</c:v>
                </c:pt>
                <c:pt idx="1">
                  <c:v>Family member/friend</c:v>
                </c:pt>
                <c:pt idx="2">
                  <c:v>Motel/hotel</c:v>
                </c:pt>
                <c:pt idx="3">
                  <c:v>Streets/park/car</c:v>
                </c:pt>
                <c:pt idx="4">
                  <c:v>Nursing home/rehab</c:v>
                </c:pt>
              </c:strCache>
            </c:strRef>
          </c:cat>
          <c:val>
            <c:numRef>
              <c:f>Sheet1!$L$82:$P$82</c:f>
              <c:numCache>
                <c:formatCode>General</c:formatCode>
                <c:ptCount val="5"/>
                <c:pt idx="0">
                  <c:v>8</c:v>
                </c:pt>
                <c:pt idx="1">
                  <c:v>5</c:v>
                </c:pt>
                <c:pt idx="2">
                  <c:v>1</c:v>
                </c:pt>
                <c:pt idx="3">
                  <c:v>9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95-4D2B-80FD-F5C10C866A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3247471"/>
        <c:axId val="51409567"/>
      </c:barChart>
      <c:catAx>
        <c:axId val="5324747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2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409567"/>
        <c:crosses val="autoZero"/>
        <c:auto val="1"/>
        <c:lblAlgn val="ctr"/>
        <c:lblOffset val="100"/>
        <c:noMultiLvlLbl val="0"/>
      </c:catAx>
      <c:valAx>
        <c:axId val="51409567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baseline="0" dirty="0">
                    <a:solidFill>
                      <a:schemeClr val="bg1"/>
                    </a:solidFill>
                  </a:rPr>
                  <a:t>Participants (n=27)</a:t>
                </a:r>
              </a:p>
            </c:rich>
          </c:tx>
          <c:layout>
            <c:manualLayout>
              <c:xMode val="edge"/>
              <c:yMode val="edge"/>
              <c:x val="0.33761714863670322"/>
              <c:y val="0.9115534920426717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2474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r>
              <a:rPr lang="en-US" sz="2800" b="1" baseline="0" dirty="0"/>
              <a:t>Substance use within past 30 days</a:t>
            </a:r>
          </a:p>
        </c:rich>
      </c:tx>
      <c:layout>
        <c:manualLayout>
          <c:xMode val="edge"/>
          <c:yMode val="edge"/>
          <c:x val="0.33355363551711814"/>
          <c:y val="2.41367623162422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bg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4120444048986948"/>
          <c:y val="0.14530330914377845"/>
          <c:w val="0.62878552512834185"/>
          <c:h val="0.66461514745492312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74948F"/>
            </a:solidFill>
            <a:ln>
              <a:solidFill>
                <a:srgbClr val="6A7472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rgbClr val="74948F"/>
              </a:solidFill>
              <a:ln>
                <a:solidFill>
                  <a:srgbClr val="74948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1DBD-4ACF-A015-986BC021DC3E}"/>
              </c:ext>
            </c:extLst>
          </c:dPt>
          <c:cat>
            <c:strRef>
              <c:f>Sheet1!$L$87:$L$92</c:f>
              <c:strCache>
                <c:ptCount val="6"/>
                <c:pt idx="0">
                  <c:v>Opioid</c:v>
                </c:pt>
                <c:pt idx="1">
                  <c:v>Methamphetamine</c:v>
                </c:pt>
                <c:pt idx="2">
                  <c:v>Alcohol</c:v>
                </c:pt>
                <c:pt idx="3">
                  <c:v>Other </c:v>
                </c:pt>
                <c:pt idx="4">
                  <c:v>Cocaine</c:v>
                </c:pt>
                <c:pt idx="5">
                  <c:v>Benzodiazepine</c:v>
                </c:pt>
              </c:strCache>
            </c:strRef>
          </c:cat>
          <c:val>
            <c:numRef>
              <c:f>Sheet1!$M$87:$M$92</c:f>
              <c:numCache>
                <c:formatCode>General</c:formatCode>
                <c:ptCount val="6"/>
                <c:pt idx="0">
                  <c:v>16</c:v>
                </c:pt>
                <c:pt idx="1">
                  <c:v>11</c:v>
                </c:pt>
                <c:pt idx="2">
                  <c:v>11</c:v>
                </c:pt>
                <c:pt idx="3">
                  <c:v>4</c:v>
                </c:pt>
                <c:pt idx="4">
                  <c:v>3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6B-47E5-8AC9-2C8145569C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618764400"/>
        <c:axId val="1613340384"/>
      </c:barChart>
      <c:catAx>
        <c:axId val="161876440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2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13340384"/>
        <c:crosses val="autoZero"/>
        <c:auto val="1"/>
        <c:lblAlgn val="ctr"/>
        <c:lblOffset val="100"/>
        <c:noMultiLvlLbl val="0"/>
      </c:catAx>
      <c:valAx>
        <c:axId val="16133403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baseline="0" dirty="0"/>
                  <a:t>Participants (n=27)</a:t>
                </a:r>
              </a:p>
            </c:rich>
          </c:tx>
          <c:layout>
            <c:manualLayout>
              <c:xMode val="edge"/>
              <c:yMode val="edge"/>
              <c:x val="0.3371782358751878"/>
              <c:y val="0.9142473416302135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bg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18764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>
          <a:solidFill>
            <a:schemeClr val="bg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5AB411-A970-42A7-A265-5A6873FBC161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4213" y="1143000"/>
            <a:ext cx="5489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C9EE06-B19F-43C7-903C-68DE0274D3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949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83560" y="3666386"/>
            <a:ext cx="29901356" cy="7799493"/>
          </a:xfrm>
        </p:spPr>
        <p:txBody>
          <a:bodyPr anchor="b"/>
          <a:lstStyle>
            <a:lvl1pPr algn="ctr">
              <a:defRPr sz="1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983560" y="11766657"/>
            <a:ext cx="29901356" cy="5408823"/>
          </a:xfrm>
        </p:spPr>
        <p:txBody>
          <a:bodyPr/>
          <a:lstStyle>
            <a:lvl1pPr marL="0" indent="0" algn="ctr">
              <a:buNone/>
              <a:defRPr sz="7840"/>
            </a:lvl1pPr>
            <a:lvl2pPr marL="1493535" indent="0" algn="ctr">
              <a:buNone/>
              <a:defRPr sz="6533"/>
            </a:lvl2pPr>
            <a:lvl3pPr marL="2987070" indent="0" algn="ctr">
              <a:buNone/>
              <a:defRPr sz="5880"/>
            </a:lvl3pPr>
            <a:lvl4pPr marL="4480606" indent="0" algn="ctr">
              <a:buNone/>
              <a:defRPr sz="5227"/>
            </a:lvl4pPr>
            <a:lvl5pPr marL="5974141" indent="0" algn="ctr">
              <a:buNone/>
              <a:defRPr sz="5227"/>
            </a:lvl5pPr>
            <a:lvl6pPr marL="7467676" indent="0" algn="ctr">
              <a:buNone/>
              <a:defRPr sz="5227"/>
            </a:lvl6pPr>
            <a:lvl7pPr marL="8961211" indent="0" algn="ctr">
              <a:buNone/>
              <a:defRPr sz="5227"/>
            </a:lvl7pPr>
            <a:lvl8pPr marL="10454747" indent="0" algn="ctr">
              <a:buNone/>
              <a:defRPr sz="5227"/>
            </a:lvl8pPr>
            <a:lvl9pPr marL="11948282" indent="0" algn="ctr">
              <a:buNone/>
              <a:defRPr sz="522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603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375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8530877" y="1192742"/>
            <a:ext cx="8596640" cy="189853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40958" y="1192742"/>
            <a:ext cx="25291564" cy="189853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830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567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20193" y="5585146"/>
            <a:ext cx="34386560" cy="9318941"/>
          </a:xfrm>
        </p:spPr>
        <p:txBody>
          <a:bodyPr anchor="b"/>
          <a:lstStyle>
            <a:lvl1pPr>
              <a:defRPr sz="1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20193" y="14992247"/>
            <a:ext cx="34386560" cy="4900611"/>
          </a:xfrm>
        </p:spPr>
        <p:txBody>
          <a:bodyPr/>
          <a:lstStyle>
            <a:lvl1pPr marL="0" indent="0">
              <a:buNone/>
              <a:defRPr sz="7840">
                <a:solidFill>
                  <a:schemeClr val="tx1">
                    <a:tint val="75000"/>
                  </a:schemeClr>
                </a:solidFill>
              </a:defRPr>
            </a:lvl1pPr>
            <a:lvl2pPr marL="1493535" indent="0">
              <a:buNone/>
              <a:defRPr sz="6533">
                <a:solidFill>
                  <a:schemeClr val="tx1">
                    <a:tint val="75000"/>
                  </a:schemeClr>
                </a:solidFill>
              </a:defRPr>
            </a:lvl2pPr>
            <a:lvl3pPr marL="2987070" indent="0">
              <a:buNone/>
              <a:defRPr sz="5880">
                <a:solidFill>
                  <a:schemeClr val="tx1">
                    <a:tint val="75000"/>
                  </a:schemeClr>
                </a:solidFill>
              </a:defRPr>
            </a:lvl3pPr>
            <a:lvl4pPr marL="4480606" indent="0">
              <a:buNone/>
              <a:defRPr sz="5227">
                <a:solidFill>
                  <a:schemeClr val="tx1">
                    <a:tint val="75000"/>
                  </a:schemeClr>
                </a:solidFill>
              </a:defRPr>
            </a:lvl4pPr>
            <a:lvl5pPr marL="5974141" indent="0">
              <a:buNone/>
              <a:defRPr sz="5227">
                <a:solidFill>
                  <a:schemeClr val="tx1">
                    <a:tint val="75000"/>
                  </a:schemeClr>
                </a:solidFill>
              </a:defRPr>
            </a:lvl5pPr>
            <a:lvl6pPr marL="7467676" indent="0">
              <a:buNone/>
              <a:defRPr sz="5227">
                <a:solidFill>
                  <a:schemeClr val="tx1">
                    <a:tint val="75000"/>
                  </a:schemeClr>
                </a:solidFill>
              </a:defRPr>
            </a:lvl6pPr>
            <a:lvl7pPr marL="8961211" indent="0">
              <a:buNone/>
              <a:defRPr sz="5227">
                <a:solidFill>
                  <a:schemeClr val="tx1">
                    <a:tint val="75000"/>
                  </a:schemeClr>
                </a:solidFill>
              </a:defRPr>
            </a:lvl7pPr>
            <a:lvl8pPr marL="10454747" indent="0">
              <a:buNone/>
              <a:defRPr sz="5227">
                <a:solidFill>
                  <a:schemeClr val="tx1">
                    <a:tint val="75000"/>
                  </a:schemeClr>
                </a:solidFill>
              </a:defRPr>
            </a:lvl8pPr>
            <a:lvl9pPr marL="11948282" indent="0">
              <a:buNone/>
              <a:defRPr sz="522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909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40958" y="5963708"/>
            <a:ext cx="16944102" cy="142143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183415" y="5963708"/>
            <a:ext cx="16944102" cy="142143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087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6150" y="1192744"/>
            <a:ext cx="34386560" cy="4330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6152" y="5491799"/>
            <a:ext cx="16866232" cy="2691446"/>
          </a:xfrm>
        </p:spPr>
        <p:txBody>
          <a:bodyPr anchor="b"/>
          <a:lstStyle>
            <a:lvl1pPr marL="0" indent="0">
              <a:buNone/>
              <a:defRPr sz="7840" b="1"/>
            </a:lvl1pPr>
            <a:lvl2pPr marL="1493535" indent="0">
              <a:buNone/>
              <a:defRPr sz="6533" b="1"/>
            </a:lvl2pPr>
            <a:lvl3pPr marL="2987070" indent="0">
              <a:buNone/>
              <a:defRPr sz="5880" b="1"/>
            </a:lvl3pPr>
            <a:lvl4pPr marL="4480606" indent="0">
              <a:buNone/>
              <a:defRPr sz="5227" b="1"/>
            </a:lvl4pPr>
            <a:lvl5pPr marL="5974141" indent="0">
              <a:buNone/>
              <a:defRPr sz="5227" b="1"/>
            </a:lvl5pPr>
            <a:lvl6pPr marL="7467676" indent="0">
              <a:buNone/>
              <a:defRPr sz="5227" b="1"/>
            </a:lvl6pPr>
            <a:lvl7pPr marL="8961211" indent="0">
              <a:buNone/>
              <a:defRPr sz="5227" b="1"/>
            </a:lvl7pPr>
            <a:lvl8pPr marL="10454747" indent="0">
              <a:buNone/>
              <a:defRPr sz="5227" b="1"/>
            </a:lvl8pPr>
            <a:lvl9pPr marL="11948282" indent="0">
              <a:buNone/>
              <a:defRPr sz="522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46152" y="8183245"/>
            <a:ext cx="16866232" cy="1203632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0183415" y="5491799"/>
            <a:ext cx="16949295" cy="2691446"/>
          </a:xfrm>
        </p:spPr>
        <p:txBody>
          <a:bodyPr anchor="b"/>
          <a:lstStyle>
            <a:lvl1pPr marL="0" indent="0">
              <a:buNone/>
              <a:defRPr sz="7840" b="1"/>
            </a:lvl1pPr>
            <a:lvl2pPr marL="1493535" indent="0">
              <a:buNone/>
              <a:defRPr sz="6533" b="1"/>
            </a:lvl2pPr>
            <a:lvl3pPr marL="2987070" indent="0">
              <a:buNone/>
              <a:defRPr sz="5880" b="1"/>
            </a:lvl3pPr>
            <a:lvl4pPr marL="4480606" indent="0">
              <a:buNone/>
              <a:defRPr sz="5227" b="1"/>
            </a:lvl4pPr>
            <a:lvl5pPr marL="5974141" indent="0">
              <a:buNone/>
              <a:defRPr sz="5227" b="1"/>
            </a:lvl5pPr>
            <a:lvl6pPr marL="7467676" indent="0">
              <a:buNone/>
              <a:defRPr sz="5227" b="1"/>
            </a:lvl6pPr>
            <a:lvl7pPr marL="8961211" indent="0">
              <a:buNone/>
              <a:defRPr sz="5227" b="1"/>
            </a:lvl7pPr>
            <a:lvl8pPr marL="10454747" indent="0">
              <a:buNone/>
              <a:defRPr sz="5227" b="1"/>
            </a:lvl8pPr>
            <a:lvl9pPr marL="11948282" indent="0">
              <a:buNone/>
              <a:defRPr sz="522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0183415" y="8183245"/>
            <a:ext cx="16949295" cy="1203632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427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209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490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6152" y="1493520"/>
            <a:ext cx="12858620" cy="5227320"/>
          </a:xfrm>
        </p:spPr>
        <p:txBody>
          <a:bodyPr anchor="b"/>
          <a:lstStyle>
            <a:lvl1pPr>
              <a:defRPr sz="104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949295" y="3225590"/>
            <a:ext cx="20183415" cy="15920508"/>
          </a:xfrm>
        </p:spPr>
        <p:txBody>
          <a:bodyPr/>
          <a:lstStyle>
            <a:lvl1pPr>
              <a:defRPr sz="10453"/>
            </a:lvl1pPr>
            <a:lvl2pPr>
              <a:defRPr sz="9147"/>
            </a:lvl2pPr>
            <a:lvl3pPr>
              <a:defRPr sz="7840"/>
            </a:lvl3pPr>
            <a:lvl4pPr>
              <a:defRPr sz="6533"/>
            </a:lvl4pPr>
            <a:lvl5pPr>
              <a:defRPr sz="6533"/>
            </a:lvl5pPr>
            <a:lvl6pPr>
              <a:defRPr sz="6533"/>
            </a:lvl6pPr>
            <a:lvl7pPr>
              <a:defRPr sz="6533"/>
            </a:lvl7pPr>
            <a:lvl8pPr>
              <a:defRPr sz="6533"/>
            </a:lvl8pPr>
            <a:lvl9pPr>
              <a:defRPr sz="65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46152" y="6720840"/>
            <a:ext cx="12858620" cy="12451187"/>
          </a:xfrm>
        </p:spPr>
        <p:txBody>
          <a:bodyPr/>
          <a:lstStyle>
            <a:lvl1pPr marL="0" indent="0">
              <a:buNone/>
              <a:defRPr sz="5227"/>
            </a:lvl1pPr>
            <a:lvl2pPr marL="1493535" indent="0">
              <a:buNone/>
              <a:defRPr sz="4573"/>
            </a:lvl2pPr>
            <a:lvl3pPr marL="2987070" indent="0">
              <a:buNone/>
              <a:defRPr sz="3920"/>
            </a:lvl3pPr>
            <a:lvl4pPr marL="4480606" indent="0">
              <a:buNone/>
              <a:defRPr sz="3267"/>
            </a:lvl4pPr>
            <a:lvl5pPr marL="5974141" indent="0">
              <a:buNone/>
              <a:defRPr sz="3267"/>
            </a:lvl5pPr>
            <a:lvl6pPr marL="7467676" indent="0">
              <a:buNone/>
              <a:defRPr sz="3267"/>
            </a:lvl6pPr>
            <a:lvl7pPr marL="8961211" indent="0">
              <a:buNone/>
              <a:defRPr sz="3267"/>
            </a:lvl7pPr>
            <a:lvl8pPr marL="10454747" indent="0">
              <a:buNone/>
              <a:defRPr sz="3267"/>
            </a:lvl8pPr>
            <a:lvl9pPr marL="11948282" indent="0">
              <a:buNone/>
              <a:defRPr sz="32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830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6152" y="1493520"/>
            <a:ext cx="12858620" cy="5227320"/>
          </a:xfrm>
        </p:spPr>
        <p:txBody>
          <a:bodyPr anchor="b"/>
          <a:lstStyle>
            <a:lvl1pPr>
              <a:defRPr sz="1045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6949295" y="3225590"/>
            <a:ext cx="20183415" cy="15920508"/>
          </a:xfrm>
        </p:spPr>
        <p:txBody>
          <a:bodyPr anchor="t"/>
          <a:lstStyle>
            <a:lvl1pPr marL="0" indent="0">
              <a:buNone/>
              <a:defRPr sz="10453"/>
            </a:lvl1pPr>
            <a:lvl2pPr marL="1493535" indent="0">
              <a:buNone/>
              <a:defRPr sz="9147"/>
            </a:lvl2pPr>
            <a:lvl3pPr marL="2987070" indent="0">
              <a:buNone/>
              <a:defRPr sz="7840"/>
            </a:lvl3pPr>
            <a:lvl4pPr marL="4480606" indent="0">
              <a:buNone/>
              <a:defRPr sz="6533"/>
            </a:lvl4pPr>
            <a:lvl5pPr marL="5974141" indent="0">
              <a:buNone/>
              <a:defRPr sz="6533"/>
            </a:lvl5pPr>
            <a:lvl6pPr marL="7467676" indent="0">
              <a:buNone/>
              <a:defRPr sz="6533"/>
            </a:lvl6pPr>
            <a:lvl7pPr marL="8961211" indent="0">
              <a:buNone/>
              <a:defRPr sz="6533"/>
            </a:lvl7pPr>
            <a:lvl8pPr marL="10454747" indent="0">
              <a:buNone/>
              <a:defRPr sz="6533"/>
            </a:lvl8pPr>
            <a:lvl9pPr marL="11948282" indent="0">
              <a:buNone/>
              <a:defRPr sz="65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46152" y="6720840"/>
            <a:ext cx="12858620" cy="12451187"/>
          </a:xfrm>
        </p:spPr>
        <p:txBody>
          <a:bodyPr/>
          <a:lstStyle>
            <a:lvl1pPr marL="0" indent="0">
              <a:buNone/>
              <a:defRPr sz="5227"/>
            </a:lvl1pPr>
            <a:lvl2pPr marL="1493535" indent="0">
              <a:buNone/>
              <a:defRPr sz="4573"/>
            </a:lvl2pPr>
            <a:lvl3pPr marL="2987070" indent="0">
              <a:buNone/>
              <a:defRPr sz="3920"/>
            </a:lvl3pPr>
            <a:lvl4pPr marL="4480606" indent="0">
              <a:buNone/>
              <a:defRPr sz="3267"/>
            </a:lvl4pPr>
            <a:lvl5pPr marL="5974141" indent="0">
              <a:buNone/>
              <a:defRPr sz="3267"/>
            </a:lvl5pPr>
            <a:lvl6pPr marL="7467676" indent="0">
              <a:buNone/>
              <a:defRPr sz="3267"/>
            </a:lvl6pPr>
            <a:lvl7pPr marL="8961211" indent="0">
              <a:buNone/>
              <a:defRPr sz="3267"/>
            </a:lvl7pPr>
            <a:lvl8pPr marL="10454747" indent="0">
              <a:buNone/>
              <a:defRPr sz="3267"/>
            </a:lvl8pPr>
            <a:lvl9pPr marL="11948282" indent="0">
              <a:buNone/>
              <a:defRPr sz="32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1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40958" y="1192744"/>
            <a:ext cx="34386560" cy="4330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0958" y="5963708"/>
            <a:ext cx="34386560" cy="142143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40958" y="20764078"/>
            <a:ext cx="8970407" cy="11927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05AC5-888C-4A55-B01D-1CBC6B164FFB}" type="datetimeFigureOut">
              <a:rPr lang="en-US" smtClean="0"/>
              <a:t>8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3206433" y="20764078"/>
            <a:ext cx="13455610" cy="11927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8157110" y="20764078"/>
            <a:ext cx="8970407" cy="11927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EEEC2-D3FB-4853-80EF-BC1574F177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563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987070" rtl="0" eaLnBrk="1" latinLnBrk="0" hangingPunct="1">
        <a:lnSpc>
          <a:spcPct val="90000"/>
        </a:lnSpc>
        <a:spcBef>
          <a:spcPct val="0"/>
        </a:spcBef>
        <a:buNone/>
        <a:defRPr sz="143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46768" indent="-746768" algn="l" defTabSz="2987070" rtl="0" eaLnBrk="1" latinLnBrk="0" hangingPunct="1">
        <a:lnSpc>
          <a:spcPct val="90000"/>
        </a:lnSpc>
        <a:spcBef>
          <a:spcPts val="3267"/>
        </a:spcBef>
        <a:buFont typeface="Arial" panose="020B0604020202020204" pitchFamily="34" charset="0"/>
        <a:buChar char="•"/>
        <a:defRPr sz="9147" kern="1200">
          <a:solidFill>
            <a:schemeClr val="tx1"/>
          </a:solidFill>
          <a:latin typeface="+mn-lt"/>
          <a:ea typeface="+mn-ea"/>
          <a:cs typeface="+mn-cs"/>
        </a:defRPr>
      </a:lvl1pPr>
      <a:lvl2pPr marL="2240303" indent="-746768" algn="l" defTabSz="2987070" rtl="0" eaLnBrk="1" latinLnBrk="0" hangingPunct="1">
        <a:lnSpc>
          <a:spcPct val="90000"/>
        </a:lnSpc>
        <a:spcBef>
          <a:spcPts val="1633"/>
        </a:spcBef>
        <a:buFont typeface="Arial" panose="020B0604020202020204" pitchFamily="34" charset="0"/>
        <a:buChar char="•"/>
        <a:defRPr sz="7840" kern="1200">
          <a:solidFill>
            <a:schemeClr val="tx1"/>
          </a:solidFill>
          <a:latin typeface="+mn-lt"/>
          <a:ea typeface="+mn-ea"/>
          <a:cs typeface="+mn-cs"/>
        </a:defRPr>
      </a:lvl2pPr>
      <a:lvl3pPr marL="3733838" indent="-746768" algn="l" defTabSz="2987070" rtl="0" eaLnBrk="1" latinLnBrk="0" hangingPunct="1">
        <a:lnSpc>
          <a:spcPct val="90000"/>
        </a:lnSpc>
        <a:spcBef>
          <a:spcPts val="1633"/>
        </a:spcBef>
        <a:buFont typeface="Arial" panose="020B0604020202020204" pitchFamily="34" charset="0"/>
        <a:buChar char="•"/>
        <a:defRPr sz="6533" kern="1200">
          <a:solidFill>
            <a:schemeClr val="tx1"/>
          </a:solidFill>
          <a:latin typeface="+mn-lt"/>
          <a:ea typeface="+mn-ea"/>
          <a:cs typeface="+mn-cs"/>
        </a:defRPr>
      </a:lvl3pPr>
      <a:lvl4pPr marL="5227373" indent="-746768" algn="l" defTabSz="2987070" rtl="0" eaLnBrk="1" latinLnBrk="0" hangingPunct="1">
        <a:lnSpc>
          <a:spcPct val="90000"/>
        </a:lnSpc>
        <a:spcBef>
          <a:spcPts val="1633"/>
        </a:spcBef>
        <a:buFont typeface="Arial" panose="020B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4pPr>
      <a:lvl5pPr marL="6720909" indent="-746768" algn="l" defTabSz="2987070" rtl="0" eaLnBrk="1" latinLnBrk="0" hangingPunct="1">
        <a:lnSpc>
          <a:spcPct val="90000"/>
        </a:lnSpc>
        <a:spcBef>
          <a:spcPts val="1633"/>
        </a:spcBef>
        <a:buFont typeface="Arial" panose="020B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5pPr>
      <a:lvl6pPr marL="8214444" indent="-746768" algn="l" defTabSz="2987070" rtl="0" eaLnBrk="1" latinLnBrk="0" hangingPunct="1">
        <a:lnSpc>
          <a:spcPct val="90000"/>
        </a:lnSpc>
        <a:spcBef>
          <a:spcPts val="1633"/>
        </a:spcBef>
        <a:buFont typeface="Arial" panose="020B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6pPr>
      <a:lvl7pPr marL="9707979" indent="-746768" algn="l" defTabSz="2987070" rtl="0" eaLnBrk="1" latinLnBrk="0" hangingPunct="1">
        <a:lnSpc>
          <a:spcPct val="90000"/>
        </a:lnSpc>
        <a:spcBef>
          <a:spcPts val="1633"/>
        </a:spcBef>
        <a:buFont typeface="Arial" panose="020B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7pPr>
      <a:lvl8pPr marL="11201514" indent="-746768" algn="l" defTabSz="2987070" rtl="0" eaLnBrk="1" latinLnBrk="0" hangingPunct="1">
        <a:lnSpc>
          <a:spcPct val="90000"/>
        </a:lnSpc>
        <a:spcBef>
          <a:spcPts val="1633"/>
        </a:spcBef>
        <a:buFont typeface="Arial" panose="020B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8pPr>
      <a:lvl9pPr marL="12695050" indent="-746768" algn="l" defTabSz="2987070" rtl="0" eaLnBrk="1" latinLnBrk="0" hangingPunct="1">
        <a:lnSpc>
          <a:spcPct val="90000"/>
        </a:lnSpc>
        <a:spcBef>
          <a:spcPts val="1633"/>
        </a:spcBef>
        <a:buFont typeface="Arial" panose="020B0604020202020204" pitchFamily="34" charset="0"/>
        <a:buChar char="•"/>
        <a:defRPr sz="58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1pPr>
      <a:lvl2pPr marL="1493535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2pPr>
      <a:lvl3pPr marL="2987070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3pPr>
      <a:lvl4pPr marL="4480606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4pPr>
      <a:lvl5pPr marL="5974141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5pPr>
      <a:lvl6pPr marL="7467676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6pPr>
      <a:lvl7pPr marL="8961211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7pPr>
      <a:lvl8pPr marL="10454747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8pPr>
      <a:lvl9pPr marL="11948282" algn="l" defTabSz="2987070" rtl="0" eaLnBrk="1" latinLnBrk="0" hangingPunct="1">
        <a:defRPr sz="58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hyperlink" Target="https://doi.org/10.1001/jamapsychiatry.2013.3575" TargetMode="External"/><Relationship Id="rId7" Type="http://schemas.openxmlformats.org/officeDocument/2006/relationships/chart" Target="../charts/chart1.xml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hyperlink" Target="https://doi.org/10.1016/j.jsat.2012.07.013" TargetMode="External"/><Relationship Id="rId5" Type="http://schemas.openxmlformats.org/officeDocument/2006/relationships/hyperlink" Target="https://doi.org/10.2147/SAR.S183252" TargetMode="External"/><Relationship Id="rId4" Type="http://schemas.openxmlformats.org/officeDocument/2006/relationships/hyperlink" Target="https://doi.org/10.2105/AJPH.2013.301302" TargetMode="External"/><Relationship Id="rId9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575757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>
            <a:extLst>
              <a:ext uri="{FF2B5EF4-FFF2-40B4-BE49-F238E27FC236}">
                <a16:creationId xmlns:a16="http://schemas.microsoft.com/office/drawing/2014/main" id="{1EF148D2-9616-4634-9492-6902369780D2}"/>
              </a:ext>
            </a:extLst>
          </p:cNvPr>
          <p:cNvSpPr/>
          <p:nvPr/>
        </p:nvSpPr>
        <p:spPr>
          <a:xfrm>
            <a:off x="0" y="1"/>
            <a:ext cx="39868475" cy="4603812"/>
          </a:xfrm>
          <a:prstGeom prst="rect">
            <a:avLst/>
          </a:prstGeom>
          <a:solidFill>
            <a:srgbClr val="6A747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7105275-B658-4EB8-AE4A-C6C0EFE697B1}"/>
              </a:ext>
            </a:extLst>
          </p:cNvPr>
          <p:cNvSpPr txBox="1"/>
          <p:nvPr/>
        </p:nvSpPr>
        <p:spPr>
          <a:xfrm>
            <a:off x="30146340" y="4686041"/>
            <a:ext cx="90598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dirty="0">
                <a:solidFill>
                  <a:schemeClr val="bg1"/>
                </a:solidFill>
              </a:rPr>
              <a:t>CONCLUSIO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B433019-B8E8-4B6F-95C9-0561B6B70C97}"/>
              </a:ext>
            </a:extLst>
          </p:cNvPr>
          <p:cNvSpPr txBox="1"/>
          <p:nvPr/>
        </p:nvSpPr>
        <p:spPr>
          <a:xfrm>
            <a:off x="10536999" y="4700259"/>
            <a:ext cx="90598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dirty="0">
                <a:solidFill>
                  <a:schemeClr val="bg1"/>
                </a:solidFill>
              </a:rPr>
              <a:t>RESULT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6FE9675-43FA-4864-BFF3-E655890677B6}"/>
              </a:ext>
            </a:extLst>
          </p:cNvPr>
          <p:cNvSpPr txBox="1"/>
          <p:nvPr/>
        </p:nvSpPr>
        <p:spPr>
          <a:xfrm>
            <a:off x="597159" y="122336"/>
            <a:ext cx="3575915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00" b="1" dirty="0">
                <a:solidFill>
                  <a:schemeClr val="bg1"/>
                </a:solidFill>
                <a:latin typeface="+mj-lt"/>
              </a:rPr>
              <a:t>Converging Vulnerabilities: Hospitalized Patients with Substance Use Disorder During the COVID-19 Pandemic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87F86548-9518-4564-9524-EAB7EF766F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19577" y="20711239"/>
            <a:ext cx="1035539" cy="170061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6935E3A-3331-447A-9BC0-1A4128E8A958}"/>
              </a:ext>
            </a:extLst>
          </p:cNvPr>
          <p:cNvSpPr txBox="1"/>
          <p:nvPr/>
        </p:nvSpPr>
        <p:spPr>
          <a:xfrm>
            <a:off x="653142" y="2800424"/>
            <a:ext cx="357591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b="1" dirty="0">
                <a:solidFill>
                  <a:schemeClr val="bg1"/>
                </a:solidFill>
              </a:rPr>
              <a:t>Dana Button</a:t>
            </a:r>
            <a:r>
              <a:rPr lang="en-US" sz="4800" b="1" baseline="30000" dirty="0">
                <a:solidFill>
                  <a:schemeClr val="bg1"/>
                </a:solidFill>
              </a:rPr>
              <a:t>1</a:t>
            </a:r>
            <a:r>
              <a:rPr lang="en-US" sz="4800" b="1" dirty="0">
                <a:solidFill>
                  <a:schemeClr val="bg1"/>
                </a:solidFill>
              </a:rPr>
              <a:t>, Caroline King</a:t>
            </a:r>
            <a:r>
              <a:rPr lang="en-US" sz="4800" b="1" baseline="30000" dirty="0">
                <a:solidFill>
                  <a:schemeClr val="bg1"/>
                </a:solidFill>
              </a:rPr>
              <a:t>1</a:t>
            </a:r>
            <a:r>
              <a:rPr lang="en-US" sz="4800" b="1" dirty="0">
                <a:solidFill>
                  <a:schemeClr val="bg1"/>
                </a:solidFill>
              </a:rPr>
              <a:t>, Taylor Vega</a:t>
            </a:r>
            <a:r>
              <a:rPr lang="en-US" sz="4800" b="1" baseline="30000" dirty="0">
                <a:solidFill>
                  <a:schemeClr val="bg1"/>
                </a:solidFill>
              </a:rPr>
              <a:t>1</a:t>
            </a:r>
            <a:r>
              <a:rPr lang="en-US" sz="4800" b="1" dirty="0">
                <a:solidFill>
                  <a:schemeClr val="bg1"/>
                </a:solidFill>
              </a:rPr>
              <a:t>, Honora Englander</a:t>
            </a:r>
            <a:r>
              <a:rPr lang="en-US" sz="4800" b="1" baseline="30000" dirty="0">
                <a:solidFill>
                  <a:schemeClr val="bg1"/>
                </a:solidFill>
              </a:rPr>
              <a:t>1,2</a:t>
            </a:r>
            <a:r>
              <a:rPr lang="en-US" sz="4800" b="1" dirty="0">
                <a:solidFill>
                  <a:schemeClr val="bg1"/>
                </a:solidFill>
              </a:rPr>
              <a:t>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83BC209-63D3-41DE-BFE9-9800C89A02CE}"/>
              </a:ext>
            </a:extLst>
          </p:cNvPr>
          <p:cNvSpPr txBox="1"/>
          <p:nvPr/>
        </p:nvSpPr>
        <p:spPr>
          <a:xfrm>
            <a:off x="662274" y="3814002"/>
            <a:ext cx="357500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1. School of Medicine, Oregon Health and Science University  2. Division of Hospital Medicine, Oregon Health and Science University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F7640A6-F38B-457C-A6BA-6F73C5E02C7F}"/>
              </a:ext>
            </a:extLst>
          </p:cNvPr>
          <p:cNvSpPr txBox="1"/>
          <p:nvPr/>
        </p:nvSpPr>
        <p:spPr>
          <a:xfrm>
            <a:off x="0" y="20307859"/>
            <a:ext cx="229017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solidFill>
                  <a:schemeClr val="bg1"/>
                </a:solidFill>
              </a:rPr>
              <a:t>REFERENCES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93263AE-DF53-4E08-915F-B8EE156210EF}"/>
              </a:ext>
            </a:extLst>
          </p:cNvPr>
          <p:cNvSpPr txBox="1"/>
          <p:nvPr/>
        </p:nvSpPr>
        <p:spPr>
          <a:xfrm>
            <a:off x="0" y="20786759"/>
            <a:ext cx="30319577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chemeClr val="bg1"/>
                </a:solidFill>
                <a:effectLst/>
              </a:rPr>
              <a:t>1. Cummings, Janet R., Hefei Wen, Michelle Ko, and Benjamin G. </a:t>
            </a:r>
            <a:r>
              <a:rPr lang="en-US" dirty="0" err="1">
                <a:solidFill>
                  <a:schemeClr val="bg1"/>
                </a:solidFill>
                <a:effectLst/>
              </a:rPr>
              <a:t>Druss</a:t>
            </a:r>
            <a:r>
              <a:rPr lang="en-US" dirty="0">
                <a:solidFill>
                  <a:schemeClr val="bg1"/>
                </a:solidFill>
                <a:effectLst/>
              </a:rPr>
              <a:t>. “Race/Ethnicity and Geographic Access to Medicaid Substance Use Disorder Treatment Facilities in the United States.” </a:t>
            </a:r>
            <a:r>
              <a:rPr lang="en-US" i="1" dirty="0">
                <a:solidFill>
                  <a:schemeClr val="bg1"/>
                </a:solidFill>
                <a:effectLst/>
              </a:rPr>
              <a:t>JAMA Psychiatry</a:t>
            </a:r>
            <a:r>
              <a:rPr lang="en-US" dirty="0">
                <a:solidFill>
                  <a:schemeClr val="bg1"/>
                </a:solidFill>
                <a:effectLst/>
              </a:rPr>
              <a:t> 71, no. 2 (February 2014): 190–96. </a:t>
            </a:r>
            <a:r>
              <a:rPr lang="en-US" dirty="0">
                <a:solidFill>
                  <a:schemeClr val="bg1"/>
                </a:solidFill>
                <a:effectLst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10.1001/jamapsychiatry.2013.3575</a:t>
            </a:r>
            <a:r>
              <a:rPr lang="en-US" dirty="0">
                <a:solidFill>
                  <a:schemeClr val="bg1"/>
                </a:solidFill>
                <a:effectLst/>
              </a:rPr>
              <a:t>. 2. </a:t>
            </a:r>
            <a:r>
              <a:rPr lang="en-US" dirty="0">
                <a:solidFill>
                  <a:schemeClr val="bg1"/>
                </a:solidFill>
              </a:rPr>
              <a:t>Thompson, Ronald G., Melanie M. Wall, Eliana Greenstein, Bridget F. Grant, and Deborah S. </a:t>
            </a:r>
            <a:r>
              <a:rPr lang="en-US" dirty="0" err="1">
                <a:solidFill>
                  <a:schemeClr val="bg1"/>
                </a:solidFill>
              </a:rPr>
              <a:t>Hasin</a:t>
            </a:r>
            <a:r>
              <a:rPr lang="en-US" dirty="0">
                <a:solidFill>
                  <a:schemeClr val="bg1"/>
                </a:solidFill>
              </a:rPr>
              <a:t>. “Substance-Use Disorders and Poverty as Prospective Predictors of First-Time Homelessness in the United States.” </a:t>
            </a:r>
            <a:r>
              <a:rPr lang="en-US" i="1" dirty="0">
                <a:solidFill>
                  <a:schemeClr val="bg1"/>
                </a:solidFill>
              </a:rPr>
              <a:t>American Journal of Public Health</a:t>
            </a:r>
            <a:r>
              <a:rPr lang="en-US" dirty="0">
                <a:solidFill>
                  <a:schemeClr val="bg1"/>
                </a:solidFill>
              </a:rPr>
              <a:t> 103, no. Suppl 2 (December 2013): S282–88. </a:t>
            </a:r>
            <a:r>
              <a:rPr lang="en-US" dirty="0">
                <a:solidFill>
                  <a:schemeClr val="bg1"/>
                </a:solidFill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10.2105/AJPH.2013.301302</a:t>
            </a:r>
            <a:r>
              <a:rPr lang="en-US" dirty="0">
                <a:solidFill>
                  <a:schemeClr val="bg1"/>
                </a:solidFill>
              </a:rPr>
              <a:t>. 3. </a:t>
            </a:r>
            <a:r>
              <a:rPr lang="en-US" dirty="0" err="1">
                <a:solidFill>
                  <a:schemeClr val="bg1"/>
                </a:solidFill>
              </a:rPr>
              <a:t>Crapanzano</a:t>
            </a:r>
            <a:r>
              <a:rPr lang="en-US" dirty="0">
                <a:solidFill>
                  <a:schemeClr val="bg1"/>
                </a:solidFill>
              </a:rPr>
              <a:t>, Kathleen A, Rebecca Hammarlund, Bilal Ahmad, Natalie Hunsinger, and </a:t>
            </a:r>
            <a:r>
              <a:rPr lang="en-US" dirty="0" err="1">
                <a:solidFill>
                  <a:schemeClr val="bg1"/>
                </a:solidFill>
              </a:rPr>
              <a:t>Rumneet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Kullar</a:t>
            </a:r>
            <a:r>
              <a:rPr lang="en-US" dirty="0">
                <a:solidFill>
                  <a:schemeClr val="bg1"/>
                </a:solidFill>
              </a:rPr>
              <a:t>. “The Association between Perceived Stigma and Substance Use Disorder Treatment Outcomes: A Review.” </a:t>
            </a:r>
            <a:r>
              <a:rPr lang="en-US" i="1" dirty="0">
                <a:solidFill>
                  <a:schemeClr val="bg1"/>
                </a:solidFill>
              </a:rPr>
              <a:t>Substance Abuse and Rehabilitation</a:t>
            </a:r>
            <a:r>
              <a:rPr lang="en-US" dirty="0">
                <a:solidFill>
                  <a:schemeClr val="bg1"/>
                </a:solidFill>
              </a:rPr>
              <a:t> 10 (December 27, 2018): 1–12. </a:t>
            </a:r>
            <a:r>
              <a:rPr lang="en-US" dirty="0">
                <a:solidFill>
                  <a:schemeClr val="bg1"/>
                </a:solidFill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10.2147/SAR.S183252</a:t>
            </a:r>
            <a:r>
              <a:rPr lang="en-US" dirty="0">
                <a:solidFill>
                  <a:schemeClr val="bg1"/>
                </a:solidFill>
              </a:rPr>
              <a:t>. 4. </a:t>
            </a:r>
            <a:r>
              <a:rPr lang="en-US" dirty="0" err="1">
                <a:solidFill>
                  <a:schemeClr val="bg1"/>
                </a:solidFill>
              </a:rPr>
              <a:t>Cacciola</a:t>
            </a:r>
            <a:r>
              <a:rPr lang="en-US" dirty="0">
                <a:solidFill>
                  <a:schemeClr val="bg1"/>
                </a:solidFill>
              </a:rPr>
              <a:t>, John S., Arthur I. Alterman, Dominick </a:t>
            </a:r>
            <a:r>
              <a:rPr lang="en-US" dirty="0" err="1">
                <a:solidFill>
                  <a:schemeClr val="bg1"/>
                </a:solidFill>
              </a:rPr>
              <a:t>DePhilippis</a:t>
            </a:r>
            <a:r>
              <a:rPr lang="en-US" dirty="0">
                <a:solidFill>
                  <a:schemeClr val="bg1"/>
                </a:solidFill>
              </a:rPr>
              <a:t>, Michelle L. </a:t>
            </a:r>
            <a:r>
              <a:rPr lang="en-US" dirty="0" err="1">
                <a:solidFill>
                  <a:schemeClr val="bg1"/>
                </a:solidFill>
              </a:rPr>
              <a:t>Drapkin</a:t>
            </a:r>
            <a:r>
              <a:rPr lang="en-US" dirty="0">
                <a:solidFill>
                  <a:schemeClr val="bg1"/>
                </a:solidFill>
              </a:rPr>
              <a:t>, Charles Valadez, Natalie C. </a:t>
            </a:r>
            <a:r>
              <a:rPr lang="en-US" dirty="0" err="1">
                <a:solidFill>
                  <a:schemeClr val="bg1"/>
                </a:solidFill>
              </a:rPr>
              <a:t>Fala</a:t>
            </a:r>
            <a:r>
              <a:rPr lang="en-US" dirty="0">
                <a:solidFill>
                  <a:schemeClr val="bg1"/>
                </a:solidFill>
              </a:rPr>
              <a:t>, David </a:t>
            </a:r>
            <a:r>
              <a:rPr lang="en-US" dirty="0" err="1">
                <a:solidFill>
                  <a:schemeClr val="bg1"/>
                </a:solidFill>
              </a:rPr>
              <a:t>Oslin</a:t>
            </a:r>
            <a:r>
              <a:rPr lang="en-US" dirty="0">
                <a:solidFill>
                  <a:schemeClr val="bg1"/>
                </a:solidFill>
              </a:rPr>
              <a:t>, and James R. McKay. “Development and Initial Evaluation of the Brief Addiction Monitor (BAM).” </a:t>
            </a:r>
            <a:r>
              <a:rPr lang="en-US" i="1" dirty="0">
                <a:solidFill>
                  <a:schemeClr val="bg1"/>
                </a:solidFill>
              </a:rPr>
              <a:t>Journal of Substance Abuse Treatment</a:t>
            </a:r>
            <a:r>
              <a:rPr lang="en-US" dirty="0">
                <a:solidFill>
                  <a:schemeClr val="bg1"/>
                </a:solidFill>
              </a:rPr>
              <a:t> 44, no. 3 (March 2013): 256–63. </a:t>
            </a:r>
            <a:r>
              <a:rPr lang="en-US" dirty="0">
                <a:solidFill>
                  <a:schemeClr val="bg1"/>
                </a:solidFill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doi.org/10.1016/j.jsat.2012.07.013</a:t>
            </a:r>
            <a:r>
              <a:rPr lang="en-US" dirty="0">
                <a:solidFill>
                  <a:schemeClr val="bg1"/>
                </a:solidFill>
              </a:rPr>
              <a:t>.</a:t>
            </a:r>
          </a:p>
          <a:p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  <a:effectLst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0D82294C-7D5E-4707-94C1-45B08B573B30}"/>
              </a:ext>
            </a:extLst>
          </p:cNvPr>
          <p:cNvSpPr/>
          <p:nvPr/>
        </p:nvSpPr>
        <p:spPr>
          <a:xfrm>
            <a:off x="-1" y="4603812"/>
            <a:ext cx="39868475" cy="575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198DDBC-E59B-4F58-9467-B6F10F3E6353}"/>
              </a:ext>
            </a:extLst>
          </p:cNvPr>
          <p:cNvSpPr txBox="1"/>
          <p:nvPr/>
        </p:nvSpPr>
        <p:spPr>
          <a:xfrm>
            <a:off x="662274" y="4691766"/>
            <a:ext cx="910667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dirty="0">
                <a:solidFill>
                  <a:schemeClr val="bg1"/>
                </a:solidFill>
              </a:rPr>
              <a:t>INTRODUCTIO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129EC66-2C23-4565-B1FB-937BF6074B9F}"/>
              </a:ext>
            </a:extLst>
          </p:cNvPr>
          <p:cNvSpPr txBox="1"/>
          <p:nvPr/>
        </p:nvSpPr>
        <p:spPr>
          <a:xfrm flipH="1">
            <a:off x="685681" y="5868685"/>
            <a:ext cx="9079639" cy="6740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Many people with substance use disorders experience harsh political, economic, and social conditions at baseline.</a:t>
            </a:r>
            <a:r>
              <a:rPr lang="en-US" sz="3600" b="1" baseline="30000" dirty="0">
                <a:solidFill>
                  <a:schemeClr val="bg1"/>
                </a:solidFill>
              </a:rPr>
              <a:t>1-3</a:t>
            </a:r>
            <a:endParaRPr lang="en-US" sz="3600" b="1" dirty="0">
              <a:solidFill>
                <a:schemeClr val="bg1"/>
              </a:solidFill>
            </a:endParaRPr>
          </a:p>
          <a:p>
            <a:pPr marL="457200" indent="-4572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Systems changes seeking to minimize viral transmission may further marginalize patients.</a:t>
            </a:r>
          </a:p>
          <a:p>
            <a:pPr marL="457200" indent="-4572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Hospitalization provides a unique window to understand the dynamic impacts of the COVID-19 pandemic on people with substance use disorders.</a:t>
            </a:r>
          </a:p>
          <a:p>
            <a:pPr marL="457200" indent="-457200" algn="just"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bg1"/>
              </a:solidFill>
            </a:endParaRPr>
          </a:p>
          <a:p>
            <a:pPr algn="just"/>
            <a:endParaRPr lang="en-US" sz="3600" dirty="0">
              <a:solidFill>
                <a:schemeClr val="bg1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1829DCA-C2D3-4B42-A575-AB3AAC6AF3F1}"/>
              </a:ext>
            </a:extLst>
          </p:cNvPr>
          <p:cNvSpPr txBox="1"/>
          <p:nvPr/>
        </p:nvSpPr>
        <p:spPr>
          <a:xfrm>
            <a:off x="682050" y="11920645"/>
            <a:ext cx="90598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dirty="0">
                <a:solidFill>
                  <a:schemeClr val="bg1"/>
                </a:solidFill>
              </a:rPr>
              <a:t>METHOD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EA28470-D83E-4320-A31A-B8D85FAE1C87}"/>
              </a:ext>
            </a:extLst>
          </p:cNvPr>
          <p:cNvSpPr txBox="1"/>
          <p:nvPr/>
        </p:nvSpPr>
        <p:spPr>
          <a:xfrm>
            <a:off x="685681" y="12970184"/>
            <a:ext cx="9059862" cy="6740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Researchers conducted individual interviews (n=27) using hospital telephones between April 15 and May 29 of 2020 to eligible patients on the inpatient addiction medicine consult service.</a:t>
            </a:r>
          </a:p>
          <a:p>
            <a:pPr marL="457200" indent="-4572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Modified Brief Addiction Monitor</a:t>
            </a:r>
            <a:r>
              <a:rPr lang="en-US" sz="3600" b="1" baseline="30000" dirty="0">
                <a:solidFill>
                  <a:schemeClr val="bg1"/>
                </a:solidFill>
              </a:rPr>
              <a:t>4</a:t>
            </a:r>
            <a:r>
              <a:rPr lang="en-US" sz="3600" b="1" dirty="0">
                <a:solidFill>
                  <a:schemeClr val="bg1"/>
                </a:solidFill>
              </a:rPr>
              <a:t> surveys were administered to participants over the phone.</a:t>
            </a:r>
          </a:p>
          <a:p>
            <a:pPr marL="457200" indent="-4572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Research team reviewed data and iteratively generated initial codes and a thematic analysis was performed.</a:t>
            </a:r>
          </a:p>
          <a:p>
            <a:endParaRPr lang="en-US" sz="36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B16F76A3-2248-45D5-95A7-86287F1B576D}"/>
              </a:ext>
            </a:extLst>
          </p:cNvPr>
          <p:cNvSpPr txBox="1"/>
          <p:nvPr/>
        </p:nvSpPr>
        <p:spPr>
          <a:xfrm>
            <a:off x="20320717" y="5869332"/>
            <a:ext cx="910667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600" b="1" dirty="0">
                <a:solidFill>
                  <a:srgbClr val="AE6963"/>
                </a:solidFill>
              </a:rPr>
              <a:t>Care Transitions are More Uncertain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D8654F5-7044-46D0-970F-7F021B1A223F}"/>
              </a:ext>
            </a:extLst>
          </p:cNvPr>
          <p:cNvSpPr txBox="1"/>
          <p:nvPr/>
        </p:nvSpPr>
        <p:spPr>
          <a:xfrm>
            <a:off x="20320717" y="6555695"/>
            <a:ext cx="9106677" cy="35394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algn="just">
              <a:spcBef>
                <a:spcPts val="0"/>
              </a:spcBef>
              <a:spcAft>
                <a:spcPts val="0"/>
              </a:spcAft>
            </a:pPr>
            <a:r>
              <a:rPr lang="en-US" sz="3200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“Even </a:t>
            </a:r>
            <a:r>
              <a:rPr lang="en-US" sz="3200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hen I get out of here, I can't go back out on the streets and be like the status that I'm in right now. It just won't work …I'll be an open target. … </a:t>
            </a:r>
            <a:r>
              <a:rPr lang="en-US" sz="3200" b="1" i="1" dirty="0">
                <a:solidFill>
                  <a:srgbClr val="AE6963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y'll come take all your medications from you.</a:t>
            </a:r>
            <a:r>
              <a:rPr lang="en-US" sz="3200" b="1" i="1" dirty="0">
                <a:solidFill>
                  <a:schemeClr val="accent4">
                    <a:lumMod val="40000"/>
                    <a:lumOff val="60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3200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y'll steal everything you own…. You got to fall asleep sometime.”</a:t>
            </a:r>
          </a:p>
          <a:p>
            <a:pPr marR="0" algn="just">
              <a:spcBef>
                <a:spcPts val="0"/>
              </a:spcBef>
              <a:spcAft>
                <a:spcPts val="0"/>
              </a:spcAft>
            </a:pPr>
            <a:r>
              <a:rPr lang="en-US" sz="32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rticipant 27 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FCEFEEE-56E6-423E-8AAD-29FA9632E21A}"/>
              </a:ext>
            </a:extLst>
          </p:cNvPr>
          <p:cNvSpPr txBox="1"/>
          <p:nvPr/>
        </p:nvSpPr>
        <p:spPr>
          <a:xfrm>
            <a:off x="20320718" y="10859976"/>
            <a:ext cx="910667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600" b="1" dirty="0">
                <a:solidFill>
                  <a:srgbClr val="74948F"/>
                </a:solidFill>
              </a:rPr>
              <a:t>Increased Reliance on Hospitals as Safety Nets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18164E1-49BB-4456-9BA0-9D36FEBFD741}"/>
              </a:ext>
            </a:extLst>
          </p:cNvPr>
          <p:cNvSpPr txBox="1"/>
          <p:nvPr/>
        </p:nvSpPr>
        <p:spPr>
          <a:xfrm>
            <a:off x="20320718" y="11550640"/>
            <a:ext cx="9106677" cy="30469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3200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“I've had hellacious problems…. Before I came to the hospital</a:t>
            </a:r>
            <a:r>
              <a:rPr lang="en-US" sz="3200" i="1" dirty="0">
                <a:solidFill>
                  <a:srgbClr val="74948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3200" b="1" i="1" dirty="0">
                <a:solidFill>
                  <a:srgbClr val="74948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 couldn’t get a doctor’s appointment for the life of me</a:t>
            </a:r>
            <a:r>
              <a:rPr lang="en-US" sz="3200" i="1" dirty="0">
                <a:solidFill>
                  <a:srgbClr val="74948F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n-US" sz="3200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o get that port out of my chest…I’m pretty sure that’s what put the clot in my heart, you know?” </a:t>
            </a:r>
          </a:p>
          <a:p>
            <a:pPr algn="just"/>
            <a:r>
              <a:rPr lang="en-US" sz="32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articipant 17</a:t>
            </a:r>
            <a:endParaRPr lang="en-US" sz="3200" b="1" dirty="0">
              <a:solidFill>
                <a:schemeClr val="bg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467D85A-0FEB-417B-BFCC-574BBF3C17CE}"/>
              </a:ext>
            </a:extLst>
          </p:cNvPr>
          <p:cNvSpPr txBox="1"/>
          <p:nvPr/>
        </p:nvSpPr>
        <p:spPr>
          <a:xfrm>
            <a:off x="20355062" y="16118178"/>
            <a:ext cx="9072333" cy="35394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3200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“The over-the-phone…it’s a little bit more cold and impersonal… There’s something about meeting a person, and looking them in the eyes, and shaking their hand that I realize for me really means a lot</a:t>
            </a:r>
            <a:r>
              <a:rPr lang="en-US" sz="3200" b="1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lang="en-US" sz="3200" b="1" i="1" dirty="0">
                <a:solidFill>
                  <a:srgbClr val="EF6E64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 can’t just open up to somebody that I just talked to on the phone</a:t>
            </a:r>
            <a:r>
              <a:rPr lang="en-US" sz="3200" b="1" i="1" dirty="0">
                <a:solidFill>
                  <a:schemeClr val="accent4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3200" i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 the same way.” </a:t>
            </a:r>
          </a:p>
          <a:p>
            <a:pPr algn="just"/>
            <a:r>
              <a:rPr lang="en-US" sz="32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rticipant 16</a:t>
            </a:r>
            <a:endParaRPr lang="en-US" sz="3200" b="1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D4E7FB73-869F-4CE7-8689-3778180D06DA}"/>
              </a:ext>
            </a:extLst>
          </p:cNvPr>
          <p:cNvSpPr txBox="1"/>
          <p:nvPr/>
        </p:nvSpPr>
        <p:spPr>
          <a:xfrm>
            <a:off x="20355062" y="15419007"/>
            <a:ext cx="90723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600" b="1" dirty="0">
                <a:solidFill>
                  <a:srgbClr val="EF6E64"/>
                </a:solidFill>
              </a:rPr>
              <a:t>Tolerating Hospitalization is More Difficult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2107014-16A2-41D3-8DE0-9E37711651BB}"/>
              </a:ext>
            </a:extLst>
          </p:cNvPr>
          <p:cNvSpPr txBox="1"/>
          <p:nvPr/>
        </p:nvSpPr>
        <p:spPr>
          <a:xfrm>
            <a:off x="30113770" y="5875682"/>
            <a:ext cx="9069024" cy="39703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571500" indent="-5715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T</a:t>
            </a:r>
            <a:r>
              <a:rPr lang="en-US" sz="36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 pandemic has exacerbated many overlapping vulnerabilities faced by marginalized communities. </a:t>
            </a:r>
            <a:endParaRPr lang="en-US" sz="3600" b="1" dirty="0">
              <a:solidFill>
                <a:schemeClr val="bg1"/>
              </a:solidFill>
            </a:endParaRPr>
          </a:p>
          <a:p>
            <a:pPr marL="571500" indent="-5715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Shuttering of community resources threatens patients’ basic survival.</a:t>
            </a:r>
          </a:p>
          <a:p>
            <a:pPr marL="571500" indent="-5715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Hospitals are a crucial safety net for people with substance use disorders.</a:t>
            </a:r>
          </a:p>
        </p:txBody>
      </p: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01C99343-BA5C-4780-9796-A8E2FE4E79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145036"/>
              </p:ext>
            </p:extLst>
          </p:nvPr>
        </p:nvGraphicFramePr>
        <p:xfrm>
          <a:off x="10806414" y="10850520"/>
          <a:ext cx="8473209" cy="3929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317624E2-4930-40F0-81BB-B31C8FED27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9233673"/>
              </p:ext>
            </p:extLst>
          </p:nvPr>
        </p:nvGraphicFramePr>
        <p:xfrm>
          <a:off x="10806413" y="15067264"/>
          <a:ext cx="8473210" cy="46124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E1D26EF8-2C7E-4FE8-AE49-294CFEA7D5B4}"/>
              </a:ext>
            </a:extLst>
          </p:cNvPr>
          <p:cNvSpPr txBox="1"/>
          <p:nvPr/>
        </p:nvSpPr>
        <p:spPr>
          <a:xfrm>
            <a:off x="30495549" y="15047196"/>
            <a:ext cx="90598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dirty="0">
                <a:solidFill>
                  <a:schemeClr val="bg1"/>
                </a:solidFill>
              </a:rPr>
              <a:t>IMPLICATION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FE7E2A1-54CB-49BF-9A78-B23465DDBA01}"/>
              </a:ext>
            </a:extLst>
          </p:cNvPr>
          <p:cNvSpPr txBox="1"/>
          <p:nvPr/>
        </p:nvSpPr>
        <p:spPr>
          <a:xfrm>
            <a:off x="30319577" y="16295175"/>
            <a:ext cx="9069024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571500" indent="-5715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Future pandemic policies should take the needs of this population into account.</a:t>
            </a:r>
          </a:p>
          <a:p>
            <a:pPr marL="571500" indent="-571500" algn="just">
              <a:buFont typeface="Arial" panose="020B0604020202020204" pitchFamily="34" charset="0"/>
              <a:buChar char="•"/>
            </a:pPr>
            <a:r>
              <a:rPr lang="en-US" sz="3600" b="1" dirty="0">
                <a:solidFill>
                  <a:schemeClr val="bg1"/>
                </a:solidFill>
              </a:rPr>
              <a:t>Care transitions during COVID-19 are increasingly unstable and more resources should be devoted to addressing these challenges.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07C4205-3E7F-4215-871F-3D1D844033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078850"/>
              </p:ext>
            </p:extLst>
          </p:nvPr>
        </p:nvGraphicFramePr>
        <p:xfrm>
          <a:off x="10806413" y="5827492"/>
          <a:ext cx="8473210" cy="4735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pSp>
        <p:nvGrpSpPr>
          <p:cNvPr id="17" name="Group 16">
            <a:extLst>
              <a:ext uri="{FF2B5EF4-FFF2-40B4-BE49-F238E27FC236}">
                <a16:creationId xmlns:a16="http://schemas.microsoft.com/office/drawing/2014/main" id="{D95DAF36-5FBD-4AB2-BD82-39B919D6E16C}"/>
              </a:ext>
            </a:extLst>
          </p:cNvPr>
          <p:cNvGrpSpPr>
            <a:grpSpLocks noChangeAspect="1"/>
          </p:cNvGrpSpPr>
          <p:nvPr/>
        </p:nvGrpSpPr>
        <p:grpSpPr>
          <a:xfrm>
            <a:off x="33280440" y="11299172"/>
            <a:ext cx="2791660" cy="2547887"/>
            <a:chOff x="10895786" y="12670442"/>
            <a:chExt cx="1568952" cy="1431948"/>
          </a:xfrm>
        </p:grpSpPr>
        <p:sp>
          <p:nvSpPr>
            <p:cNvPr id="51" name="Oval 50">
              <a:extLst>
                <a:ext uri="{FF2B5EF4-FFF2-40B4-BE49-F238E27FC236}">
                  <a16:creationId xmlns:a16="http://schemas.microsoft.com/office/drawing/2014/main" id="{E4E744EC-DF54-4895-B2BB-3060E7844AC7}"/>
                </a:ext>
              </a:extLst>
            </p:cNvPr>
            <p:cNvSpPr/>
            <p:nvPr/>
          </p:nvSpPr>
          <p:spPr>
            <a:xfrm>
              <a:off x="10895786" y="12670442"/>
              <a:ext cx="914400" cy="914400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n>
                  <a:solidFill>
                    <a:schemeClr val="bg1"/>
                  </a:solidFill>
                </a:ln>
                <a:noFill/>
              </a:endParaRPr>
            </a:p>
          </p:txBody>
        </p:sp>
        <p:sp>
          <p:nvSpPr>
            <p:cNvPr id="52" name="Oval 51">
              <a:extLst>
                <a:ext uri="{FF2B5EF4-FFF2-40B4-BE49-F238E27FC236}">
                  <a16:creationId xmlns:a16="http://schemas.microsoft.com/office/drawing/2014/main" id="{24BB0045-5B07-46D5-AA16-8E856B1C8633}"/>
                </a:ext>
              </a:extLst>
            </p:cNvPr>
            <p:cNvSpPr/>
            <p:nvPr/>
          </p:nvSpPr>
          <p:spPr>
            <a:xfrm>
              <a:off x="11221355" y="13187990"/>
              <a:ext cx="914400" cy="914400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n>
                  <a:solidFill>
                    <a:schemeClr val="bg1"/>
                  </a:solidFill>
                </a:ln>
                <a:noFill/>
              </a:endParaRPr>
            </a:p>
          </p:txBody>
        </p:sp>
        <p:sp>
          <p:nvSpPr>
            <p:cNvPr id="53" name="Oval 52">
              <a:extLst>
                <a:ext uri="{FF2B5EF4-FFF2-40B4-BE49-F238E27FC236}">
                  <a16:creationId xmlns:a16="http://schemas.microsoft.com/office/drawing/2014/main" id="{3C29DABA-7653-403D-8747-0C95AB52E79F}"/>
                </a:ext>
              </a:extLst>
            </p:cNvPr>
            <p:cNvSpPr/>
            <p:nvPr/>
          </p:nvSpPr>
          <p:spPr>
            <a:xfrm>
              <a:off x="11550338" y="12672390"/>
              <a:ext cx="914400" cy="914400"/>
            </a:xfrm>
            <a:prstGeom prst="ellipse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>
                <a:ln>
                  <a:solidFill>
                    <a:schemeClr val="bg1"/>
                  </a:solidFill>
                </a:ln>
                <a:noFill/>
              </a:endParaRPr>
            </a:p>
          </p:txBody>
        </p:sp>
      </p:grpSp>
      <p:sp>
        <p:nvSpPr>
          <p:cNvPr id="22" name="TextBox 10">
            <a:extLst>
              <a:ext uri="{FF2B5EF4-FFF2-40B4-BE49-F238E27FC236}">
                <a16:creationId xmlns:a16="http://schemas.microsoft.com/office/drawing/2014/main" id="{456C02BF-59B6-48DB-BF3C-BA83962161B5}"/>
              </a:ext>
            </a:extLst>
          </p:cNvPr>
          <p:cNvSpPr txBox="1"/>
          <p:nvPr/>
        </p:nvSpPr>
        <p:spPr>
          <a:xfrm>
            <a:off x="32307609" y="13996005"/>
            <a:ext cx="543574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4000" b="1" dirty="0">
                <a:solidFill>
                  <a:schemeClr val="bg1"/>
                </a:solidFill>
              </a:rPr>
              <a:t>Substance Use Disorder</a:t>
            </a:r>
          </a:p>
        </p:txBody>
      </p:sp>
      <p:sp>
        <p:nvSpPr>
          <p:cNvPr id="23" name="TextBox 13">
            <a:extLst>
              <a:ext uri="{FF2B5EF4-FFF2-40B4-BE49-F238E27FC236}">
                <a16:creationId xmlns:a16="http://schemas.microsoft.com/office/drawing/2014/main" id="{BE282908-180A-41FC-A8A3-BDFAE2795FB3}"/>
              </a:ext>
            </a:extLst>
          </p:cNvPr>
          <p:cNvSpPr txBox="1"/>
          <p:nvPr/>
        </p:nvSpPr>
        <p:spPr>
          <a:xfrm>
            <a:off x="33830905" y="10520635"/>
            <a:ext cx="543574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4000" b="1" dirty="0">
                <a:solidFill>
                  <a:schemeClr val="bg1"/>
                </a:solidFill>
              </a:rPr>
              <a:t>COVID-19</a:t>
            </a:r>
          </a:p>
        </p:txBody>
      </p:sp>
      <p:sp>
        <p:nvSpPr>
          <p:cNvPr id="24" name="TextBox 12">
            <a:extLst>
              <a:ext uri="{FF2B5EF4-FFF2-40B4-BE49-F238E27FC236}">
                <a16:creationId xmlns:a16="http://schemas.microsoft.com/office/drawing/2014/main" id="{9B3AC54E-A82C-4D74-B257-3223B6B927E0}"/>
              </a:ext>
            </a:extLst>
          </p:cNvPr>
          <p:cNvSpPr txBox="1"/>
          <p:nvPr/>
        </p:nvSpPr>
        <p:spPr>
          <a:xfrm>
            <a:off x="30791452" y="10504170"/>
            <a:ext cx="543574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4000" b="1" dirty="0">
                <a:solidFill>
                  <a:schemeClr val="bg1"/>
                </a:solidFill>
              </a:rPr>
              <a:t>Hospitalizat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4EA09E1-AD04-4841-A5A9-41E02696CFDF}"/>
              </a:ext>
            </a:extLst>
          </p:cNvPr>
          <p:cNvSpPr txBox="1"/>
          <p:nvPr/>
        </p:nvSpPr>
        <p:spPr>
          <a:xfrm>
            <a:off x="20431866" y="4686309"/>
            <a:ext cx="90598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200" dirty="0">
                <a:solidFill>
                  <a:schemeClr val="bg1"/>
                </a:solidFill>
              </a:rPr>
              <a:t>RESULTS</a:t>
            </a:r>
          </a:p>
        </p:txBody>
      </p:sp>
    </p:spTree>
    <p:extLst>
      <p:ext uri="{BB962C8B-B14F-4D97-AF65-F5344CB8AC3E}">
        <p14:creationId xmlns:p14="http://schemas.microsoft.com/office/powerpoint/2010/main" val="27302300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6</TotalTime>
  <Words>735</Words>
  <Application>Microsoft Office PowerPoint</Application>
  <PresentationFormat>Custom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a Button</dc:creator>
  <cp:lastModifiedBy>Dana Button</cp:lastModifiedBy>
  <cp:revision>137</cp:revision>
  <dcterms:created xsi:type="dcterms:W3CDTF">2020-08-04T14:10:50Z</dcterms:created>
  <dcterms:modified xsi:type="dcterms:W3CDTF">2020-09-01T02:11:19Z</dcterms:modified>
</cp:coreProperties>
</file>